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12192000" cy="10817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>
        <p:scale>
          <a:sx n="40" d="100"/>
          <a:sy n="40" d="100"/>
        </p:scale>
        <p:origin x="158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70320"/>
            <a:ext cx="10363200" cy="376599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681548"/>
            <a:ext cx="9144000" cy="261165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3500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690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75917"/>
            <a:ext cx="2628900" cy="916709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75917"/>
            <a:ext cx="7734300" cy="916709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5547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0114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96798"/>
            <a:ext cx="10515600" cy="449966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239030"/>
            <a:ext cx="10515600" cy="236626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121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879585"/>
            <a:ext cx="5181600" cy="6863430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79585"/>
            <a:ext cx="5181600" cy="6863430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0868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5920"/>
            <a:ext cx="10515600" cy="209083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651723"/>
            <a:ext cx="5157787" cy="129956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951292"/>
            <a:ext cx="5157787" cy="581175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51723"/>
            <a:ext cx="5183188" cy="129956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951292"/>
            <a:ext cx="5183188" cy="581175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8774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3684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8246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21148"/>
            <a:ext cx="3932237" cy="252401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57482"/>
            <a:ext cx="6172200" cy="768724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45168"/>
            <a:ext cx="3932237" cy="601207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329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21148"/>
            <a:ext cx="3932237" cy="252401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57482"/>
            <a:ext cx="6172200" cy="768724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45168"/>
            <a:ext cx="3932237" cy="601207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0055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75920"/>
            <a:ext cx="10515600" cy="209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79585"/>
            <a:ext cx="10515600" cy="68634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025967"/>
            <a:ext cx="2743200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CAAC1-B734-4340-A86E-CA4E7CC5E20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025967"/>
            <a:ext cx="4114800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025967"/>
            <a:ext cx="2743200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588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"/><Relationship Id="rId3" Type="http://schemas.openxmlformats.org/officeDocument/2006/relationships/image" Target="../media/image12.tiff"/><Relationship Id="rId7" Type="http://schemas.openxmlformats.org/officeDocument/2006/relationships/image" Target="../media/image16.ti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"/><Relationship Id="rId11" Type="http://schemas.openxmlformats.org/officeDocument/2006/relationships/image" Target="../media/image20.tif"/><Relationship Id="rId5" Type="http://schemas.openxmlformats.org/officeDocument/2006/relationships/image" Target="../media/image14.tif"/><Relationship Id="rId10" Type="http://schemas.openxmlformats.org/officeDocument/2006/relationships/image" Target="../media/image19.tif"/><Relationship Id="rId4" Type="http://schemas.openxmlformats.org/officeDocument/2006/relationships/image" Target="../media/image13.tif"/><Relationship Id="rId9" Type="http://schemas.openxmlformats.org/officeDocument/2006/relationships/image" Target="../media/image18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3" Type="http://schemas.openxmlformats.org/officeDocument/2006/relationships/image" Target="../media/image22.tiff"/><Relationship Id="rId7" Type="http://schemas.openxmlformats.org/officeDocument/2006/relationships/image" Target="../media/image26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tiff"/><Relationship Id="rId11" Type="http://schemas.openxmlformats.org/officeDocument/2006/relationships/image" Target="../media/image30.tiff"/><Relationship Id="rId5" Type="http://schemas.openxmlformats.org/officeDocument/2006/relationships/image" Target="../media/image24.tiff"/><Relationship Id="rId10" Type="http://schemas.openxmlformats.org/officeDocument/2006/relationships/image" Target="../media/image29.tiff"/><Relationship Id="rId4" Type="http://schemas.openxmlformats.org/officeDocument/2006/relationships/image" Target="../media/image23.tiff"/><Relationship Id="rId9" Type="http://schemas.openxmlformats.org/officeDocument/2006/relationships/image" Target="../media/image2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2" Type="http://schemas.openxmlformats.org/officeDocument/2006/relationships/image" Target="../media/image3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图片 6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2833" y="3359980"/>
            <a:ext cx="2111790" cy="2520000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7239" y="3359980"/>
            <a:ext cx="2108217" cy="252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15929" y="412130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CSL3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30FE183-A2E5-1AC4-72FA-0BAD70331461}"/>
              </a:ext>
            </a:extLst>
          </p:cNvPr>
          <p:cNvSpPr txBox="1"/>
          <p:nvPr/>
        </p:nvSpPr>
        <p:spPr>
          <a:xfrm rot="-5400000">
            <a:off x="215929" y="66893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PX4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702" y="3273515"/>
            <a:ext cx="2087896" cy="25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2930" y="3273515"/>
            <a:ext cx="2121523" cy="252000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753056" y="412130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1537" y="6007675"/>
            <a:ext cx="2062061" cy="252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082" y="6000686"/>
            <a:ext cx="2061490" cy="2520000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768809" y="66893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76071" y="14231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Rf2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60281" y="3988271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LC7a11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60281" y="68392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fR1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421114" y="688756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421114" y="39485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421114" y="14231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6" name="矩形 35"/>
          <p:cNvSpPr/>
          <p:nvPr/>
        </p:nvSpPr>
        <p:spPr>
          <a:xfrm>
            <a:off x="1789866" y="4066304"/>
            <a:ext cx="1064170" cy="221680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1665802" y="8077196"/>
            <a:ext cx="1132815" cy="22860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41"/>
          <p:cNvSpPr txBox="1"/>
          <p:nvPr/>
        </p:nvSpPr>
        <p:spPr>
          <a:xfrm>
            <a:off x="534089" y="188570"/>
            <a:ext cx="4246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</a:t>
            </a:r>
            <a:r>
              <a:rPr lang="en-US" altLang="zh-CN" dirty="0" smtClean="0"/>
              <a:t>4B A549 A549RR H1299 H1299RR</a:t>
            </a:r>
            <a:endParaRPr lang="zh-CN" altLang="en-US" dirty="0"/>
          </a:p>
        </p:txBody>
      </p:sp>
      <p:pic>
        <p:nvPicPr>
          <p:cNvPr id="49" name="图片 4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8625" y="753515"/>
            <a:ext cx="2096000" cy="2520000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3667" y="753515"/>
            <a:ext cx="2111789" cy="2520000"/>
          </a:xfrm>
          <a:prstGeom prst="rect">
            <a:avLst/>
          </a:prstGeom>
        </p:spPr>
      </p:pic>
      <p:sp>
        <p:nvSpPr>
          <p:cNvPr id="53" name="矩形 52"/>
          <p:cNvSpPr/>
          <p:nvPr/>
        </p:nvSpPr>
        <p:spPr>
          <a:xfrm>
            <a:off x="7286176" y="1589282"/>
            <a:ext cx="1146807" cy="175510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0" name="图片 59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2835" y="6007675"/>
            <a:ext cx="2111790" cy="2520000"/>
          </a:xfrm>
          <a:prstGeom prst="rect">
            <a:avLst/>
          </a:prstGeom>
        </p:spPr>
      </p:pic>
      <p:pic>
        <p:nvPicPr>
          <p:cNvPr id="61" name="图片 6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3668" y="6007675"/>
            <a:ext cx="2111789" cy="2520000"/>
          </a:xfrm>
          <a:prstGeom prst="rect">
            <a:avLst/>
          </a:prstGeom>
        </p:spPr>
      </p:pic>
      <p:sp>
        <p:nvSpPr>
          <p:cNvPr id="64" name="矩形 63"/>
          <p:cNvSpPr/>
          <p:nvPr/>
        </p:nvSpPr>
        <p:spPr>
          <a:xfrm>
            <a:off x="7286175" y="4411196"/>
            <a:ext cx="1146808" cy="215667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矩形 64"/>
          <p:cNvSpPr/>
          <p:nvPr/>
        </p:nvSpPr>
        <p:spPr>
          <a:xfrm>
            <a:off x="9793002" y="4411422"/>
            <a:ext cx="1225517" cy="215442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/>
          <p:cNvSpPr/>
          <p:nvPr/>
        </p:nvSpPr>
        <p:spPr>
          <a:xfrm>
            <a:off x="7155323" y="6575277"/>
            <a:ext cx="1277659" cy="19128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121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图片 4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8625" y="3273515"/>
            <a:ext cx="2096000" cy="2520000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3666" y="3273515"/>
            <a:ext cx="2111789" cy="2520000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8625" y="6184915"/>
            <a:ext cx="2096000" cy="2520000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3666" y="6202585"/>
            <a:ext cx="2111789" cy="252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194" y="3273515"/>
            <a:ext cx="2065404" cy="25200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534089" y="188570"/>
            <a:ext cx="4540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</a:t>
            </a:r>
            <a:r>
              <a:rPr lang="en-US" altLang="zh-CN" dirty="0" smtClean="0"/>
              <a:t>4B SW837 SW837RR CMT93 CMT93RR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15929" y="412130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CSL3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30FE183-A2E5-1AC4-72FA-0BAD70331461}"/>
              </a:ext>
            </a:extLst>
          </p:cNvPr>
          <p:cNvSpPr txBox="1"/>
          <p:nvPr/>
        </p:nvSpPr>
        <p:spPr>
          <a:xfrm rot="-5400000">
            <a:off x="215929" y="66893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PX4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753056" y="412130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768809" y="66893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76071" y="14231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Rf2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60281" y="3988271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LC7a11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60281" y="68392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fR1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421114" y="688756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421114" y="39485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421114" y="14231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6" name="矩形 35"/>
          <p:cNvSpPr/>
          <p:nvPr/>
        </p:nvSpPr>
        <p:spPr>
          <a:xfrm>
            <a:off x="1493058" y="4062096"/>
            <a:ext cx="1186134" cy="243871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7042165" y="4305968"/>
            <a:ext cx="1139388" cy="189832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7042165" y="6816824"/>
            <a:ext cx="1229443" cy="182905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/>
          <p:cNvSpPr/>
          <p:nvPr/>
        </p:nvSpPr>
        <p:spPr>
          <a:xfrm>
            <a:off x="9602998" y="4400884"/>
            <a:ext cx="1214429" cy="189832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514" y="3273515"/>
            <a:ext cx="2068977" cy="252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194" y="6202585"/>
            <a:ext cx="2065404" cy="252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2930" y="6213921"/>
            <a:ext cx="2055561" cy="252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1261" y="583243"/>
            <a:ext cx="2113364" cy="252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3667" y="530381"/>
            <a:ext cx="2111789" cy="2520000"/>
          </a:xfrm>
          <a:prstGeom prst="rect">
            <a:avLst/>
          </a:prstGeom>
        </p:spPr>
      </p:pic>
      <p:sp>
        <p:nvSpPr>
          <p:cNvPr id="42" name="矩形 41"/>
          <p:cNvSpPr/>
          <p:nvPr/>
        </p:nvSpPr>
        <p:spPr>
          <a:xfrm>
            <a:off x="1492552" y="8265257"/>
            <a:ext cx="1345365" cy="262418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7075544" y="1418001"/>
            <a:ext cx="1346080" cy="150328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2571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34089" y="188570"/>
            <a:ext cx="4540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</a:t>
            </a:r>
            <a:r>
              <a:rPr lang="en-US" altLang="zh-CN" dirty="0" smtClean="0"/>
              <a:t>4E SW837 SW837RR CMT93 CMT93RR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-212948" y="412130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CSL3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30FE183-A2E5-1AC4-72FA-0BAD70331461}"/>
              </a:ext>
            </a:extLst>
          </p:cNvPr>
          <p:cNvSpPr txBox="1"/>
          <p:nvPr/>
        </p:nvSpPr>
        <p:spPr>
          <a:xfrm rot="-5400000">
            <a:off x="-172382" y="66893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PX4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753056" y="412130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2768809" y="66893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76071" y="14231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Rf2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60281" y="3988271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LC7a11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860281" y="68392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fR1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779526" y="6839235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826087" y="3900818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779526" y="1405630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576" y="3373210"/>
            <a:ext cx="2481267" cy="25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1574" y="3373210"/>
            <a:ext cx="2482332" cy="252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305" y="6203803"/>
            <a:ext cx="2467811" cy="252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2480" y="6198080"/>
            <a:ext cx="2476795" cy="252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2835" y="689861"/>
            <a:ext cx="2490069" cy="252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2080" y="678085"/>
            <a:ext cx="2426522" cy="2520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8414" y="3373210"/>
            <a:ext cx="2474490" cy="252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2080" y="3361268"/>
            <a:ext cx="2426522" cy="252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8414" y="6198080"/>
            <a:ext cx="2474490" cy="252000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2080" y="5977596"/>
            <a:ext cx="2426522" cy="2520000"/>
          </a:xfrm>
          <a:prstGeom prst="rect">
            <a:avLst/>
          </a:prstGeom>
        </p:spPr>
      </p:pic>
      <p:sp>
        <p:nvSpPr>
          <p:cNvPr id="40" name="矩形 39"/>
          <p:cNvSpPr/>
          <p:nvPr/>
        </p:nvSpPr>
        <p:spPr>
          <a:xfrm>
            <a:off x="1134420" y="4051001"/>
            <a:ext cx="1508196" cy="246679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矩形 48"/>
          <p:cNvSpPr/>
          <p:nvPr/>
        </p:nvSpPr>
        <p:spPr>
          <a:xfrm>
            <a:off x="1134420" y="8210393"/>
            <a:ext cx="1580996" cy="21544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 49"/>
          <p:cNvSpPr/>
          <p:nvPr/>
        </p:nvSpPr>
        <p:spPr>
          <a:xfrm>
            <a:off x="7117801" y="1501921"/>
            <a:ext cx="1633007" cy="211823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矩形 50"/>
          <p:cNvSpPr/>
          <p:nvPr/>
        </p:nvSpPr>
        <p:spPr>
          <a:xfrm>
            <a:off x="7261252" y="4380804"/>
            <a:ext cx="1580996" cy="21544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矩形 51"/>
          <p:cNvSpPr/>
          <p:nvPr/>
        </p:nvSpPr>
        <p:spPr>
          <a:xfrm>
            <a:off x="10141612" y="4380804"/>
            <a:ext cx="1580996" cy="21544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矩形 52"/>
          <p:cNvSpPr/>
          <p:nvPr/>
        </p:nvSpPr>
        <p:spPr>
          <a:xfrm>
            <a:off x="7247355" y="6766279"/>
            <a:ext cx="1580996" cy="21544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矩形 53"/>
          <p:cNvSpPr/>
          <p:nvPr/>
        </p:nvSpPr>
        <p:spPr>
          <a:xfrm>
            <a:off x="10076327" y="7210164"/>
            <a:ext cx="1580996" cy="21544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8945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34089" y="188570"/>
            <a:ext cx="6154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</a:t>
            </a:r>
            <a:r>
              <a:rPr lang="en-US" altLang="zh-CN" dirty="0" smtClean="0"/>
              <a:t>6B SW837 SW837-OEACSL3 CMT93 CMT93</a:t>
            </a:r>
            <a:r>
              <a:rPr lang="en-US" altLang="zh-CN" dirty="0"/>
              <a:t>-OEACSL3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598701" y="2526418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CSL3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3135828" y="2526418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126" y="1735832"/>
            <a:ext cx="2046830" cy="25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5701" y="1735832"/>
            <a:ext cx="2055561" cy="2520000"/>
          </a:xfrm>
          <a:prstGeom prst="rect">
            <a:avLst/>
          </a:prstGeom>
        </p:spPr>
      </p:pic>
      <p:sp>
        <p:nvSpPr>
          <p:cNvPr id="37" name="矩形 36"/>
          <p:cNvSpPr/>
          <p:nvPr/>
        </p:nvSpPr>
        <p:spPr>
          <a:xfrm>
            <a:off x="1882084" y="2357584"/>
            <a:ext cx="1186134" cy="243871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/>
          <p:cNvSpPr/>
          <p:nvPr/>
        </p:nvSpPr>
        <p:spPr>
          <a:xfrm>
            <a:off x="4322250" y="2838384"/>
            <a:ext cx="1186134" cy="243871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352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</TotalTime>
  <Words>56</Words>
  <Application>Microsoft Office PowerPoint</Application>
  <PresentationFormat>自定义</PresentationFormat>
  <Paragraphs>3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 Tong</dc:creator>
  <cp:lastModifiedBy>CYL</cp:lastModifiedBy>
  <cp:revision>14</cp:revision>
  <dcterms:created xsi:type="dcterms:W3CDTF">2024-02-18T01:33:20Z</dcterms:created>
  <dcterms:modified xsi:type="dcterms:W3CDTF">2025-01-07T14:06:04Z</dcterms:modified>
</cp:coreProperties>
</file>